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475" userDrawn="1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99" d="100"/>
          <a:sy n="99" d="100"/>
        </p:scale>
        <p:origin x="246" y="90"/>
      </p:cViewPr>
      <p:guideLst>
        <p:guide orient="horz" pos="3475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AD089-D445-47A7-9A9C-3DB0A4B2FA49}" type="datetimeFigureOut">
              <a:rPr lang="en-IN" smtClean="0"/>
              <a:t>28-12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59F15-6276-47F2-92F6-FCB9574CC5A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336417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AD089-D445-47A7-9A9C-3DB0A4B2FA49}" type="datetimeFigureOut">
              <a:rPr lang="en-IN" smtClean="0"/>
              <a:t>28-12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59F15-6276-47F2-92F6-FCB9574CC5A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078015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AD089-D445-47A7-9A9C-3DB0A4B2FA49}" type="datetimeFigureOut">
              <a:rPr lang="en-IN" smtClean="0"/>
              <a:t>28-12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59F15-6276-47F2-92F6-FCB9574CC5A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94352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AD089-D445-47A7-9A9C-3DB0A4B2FA49}" type="datetimeFigureOut">
              <a:rPr lang="en-IN" smtClean="0"/>
              <a:t>28-12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59F15-6276-47F2-92F6-FCB9574CC5A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387350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AD089-D445-47A7-9A9C-3DB0A4B2FA49}" type="datetimeFigureOut">
              <a:rPr lang="en-IN" smtClean="0"/>
              <a:t>28-12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59F15-6276-47F2-92F6-FCB9574CC5A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519155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AD089-D445-47A7-9A9C-3DB0A4B2FA49}" type="datetimeFigureOut">
              <a:rPr lang="en-IN" smtClean="0"/>
              <a:t>28-12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59F15-6276-47F2-92F6-FCB9574CC5A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976067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AD089-D445-47A7-9A9C-3DB0A4B2FA49}" type="datetimeFigureOut">
              <a:rPr lang="en-IN" smtClean="0"/>
              <a:t>28-12-2015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59F15-6276-47F2-92F6-FCB9574CC5A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369483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AD089-D445-47A7-9A9C-3DB0A4B2FA49}" type="datetimeFigureOut">
              <a:rPr lang="en-IN" smtClean="0"/>
              <a:t>28-12-2015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59F15-6276-47F2-92F6-FCB9574CC5A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547979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AD089-D445-47A7-9A9C-3DB0A4B2FA49}" type="datetimeFigureOut">
              <a:rPr lang="en-IN" smtClean="0"/>
              <a:t>28-12-2015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59F15-6276-47F2-92F6-FCB9574CC5A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352567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AD089-D445-47A7-9A9C-3DB0A4B2FA49}" type="datetimeFigureOut">
              <a:rPr lang="en-IN" smtClean="0"/>
              <a:t>28-12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59F15-6276-47F2-92F6-FCB9574CC5A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702584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AD089-D445-47A7-9A9C-3DB0A4B2FA49}" type="datetimeFigureOut">
              <a:rPr lang="en-IN" smtClean="0"/>
              <a:t>28-12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59F15-6276-47F2-92F6-FCB9574CC5A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656488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8AD089-D445-47A7-9A9C-3DB0A4B2FA49}" type="datetimeFigureOut">
              <a:rPr lang="en-IN" smtClean="0"/>
              <a:t>28-12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559F15-6276-47F2-92F6-FCB9574CC5A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371284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1283369" y="5315551"/>
            <a:ext cx="6527529" cy="12249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0"/>
              </a:spcAft>
            </a:pPr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Mangal"/>
              </a:rPr>
              <a:t>S2 Fig. Molecular confirmation of transgenic tobacco lines. 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Mangal"/>
              </a:rPr>
              <a:t>PCR amplification of the </a:t>
            </a:r>
            <a:r>
              <a:rPr lang="en-US" sz="1600" i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Mangal"/>
              </a:rPr>
              <a:t>hptII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Mangal"/>
              </a:rPr>
              <a:t> gene using DNA templet extracted from putative transgenic tobacco plants transformed with (</a:t>
            </a:r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Mangal"/>
              </a:rPr>
              <a:t>a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Mangal"/>
              </a:rPr>
              <a:t>) GP1, (</a:t>
            </a:r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Mangal"/>
              </a:rPr>
              <a:t>b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Mangal"/>
              </a:rPr>
              <a:t>) GP2, (</a:t>
            </a:r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Mangal"/>
              </a:rPr>
              <a:t>c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Mangal"/>
              </a:rPr>
              <a:t>) GP3 or (</a:t>
            </a:r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Mangal"/>
              </a:rPr>
              <a:t>d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Mangal"/>
              </a:rPr>
              <a:t>) GP4 promoter constructs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Mangal"/>
            </a:endParaRPr>
          </a:p>
        </p:txBody>
      </p:sp>
      <p:grpSp>
        <p:nvGrpSpPr>
          <p:cNvPr id="8" name="Group 7"/>
          <p:cNvGrpSpPr/>
          <p:nvPr/>
        </p:nvGrpSpPr>
        <p:grpSpPr>
          <a:xfrm>
            <a:off x="1273779" y="792903"/>
            <a:ext cx="6603960" cy="4582444"/>
            <a:chOff x="1273779" y="792903"/>
            <a:chExt cx="6603960" cy="4582444"/>
          </a:xfrm>
        </p:grpSpPr>
        <p:grpSp>
          <p:nvGrpSpPr>
            <p:cNvPr id="74" name="Group 73"/>
            <p:cNvGrpSpPr/>
            <p:nvPr/>
          </p:nvGrpSpPr>
          <p:grpSpPr>
            <a:xfrm>
              <a:off x="1273779" y="792903"/>
              <a:ext cx="6603960" cy="4483639"/>
              <a:chOff x="1225651" y="792903"/>
              <a:chExt cx="6603960" cy="4483639"/>
            </a:xfrm>
          </p:grpSpPr>
          <p:grpSp>
            <p:nvGrpSpPr>
              <p:cNvPr id="2" name="Group 1"/>
              <p:cNvGrpSpPr/>
              <p:nvPr/>
            </p:nvGrpSpPr>
            <p:grpSpPr>
              <a:xfrm>
                <a:off x="1225651" y="792903"/>
                <a:ext cx="3274341" cy="2227553"/>
                <a:chOff x="1225651" y="792903"/>
                <a:chExt cx="3274341" cy="2227553"/>
              </a:xfrm>
            </p:grpSpPr>
            <p:pic>
              <p:nvPicPr>
                <p:cNvPr id="16" name="Picture 4" descr="D:\Vivek\Gel pictrures\00 walking\vivek\Final Photograph\A2 transgenic lines + hpt\UVP_00008Oct062010.JPG"/>
                <p:cNvPicPr>
                  <a:picLocks noChangeArrowheads="1"/>
                </p:cNvPicPr>
                <p:nvPr/>
              </p:nvPicPr>
              <p:blipFill rotWithShape="1">
                <a:blip r:embed="rId2" cstate="print"/>
                <a:srcRect l="6667" t="3177" r="37500" b="32223"/>
                <a:stretch/>
              </p:blipFill>
              <p:spPr bwMode="auto">
                <a:xfrm>
                  <a:off x="1225651" y="860456"/>
                  <a:ext cx="3240000" cy="21600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6" name="TextBox 18"/>
                <p:cNvSpPr txBox="1">
                  <a:spLocks noChangeArrowheads="1"/>
                </p:cNvSpPr>
                <p:nvPr/>
              </p:nvSpPr>
              <p:spPr bwMode="auto">
                <a:xfrm>
                  <a:off x="1276033" y="792903"/>
                  <a:ext cx="3223959" cy="3077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400" dirty="0" smtClean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  +</a:t>
                  </a:r>
                  <a:r>
                    <a:rPr lang="en-US" sz="1400" dirty="0" err="1" smtClean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ve</a:t>
                  </a:r>
                  <a:r>
                    <a:rPr lang="en-US" sz="1400" dirty="0" smtClean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-</a:t>
                  </a:r>
                  <a:r>
                    <a:rPr lang="en-US" sz="1400" dirty="0" err="1" smtClean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ve</a:t>
                  </a:r>
                  <a:r>
                    <a:rPr lang="en-US" sz="1400" dirty="0" smtClean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L1  L2   L3  L4   L5   L6   L7</a:t>
                  </a:r>
                  <a:endParaRPr lang="en-US" sz="14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3" name="Group 2"/>
              <p:cNvGrpSpPr/>
              <p:nvPr/>
            </p:nvGrpSpPr>
            <p:grpSpPr>
              <a:xfrm>
                <a:off x="4523959" y="801040"/>
                <a:ext cx="3305652" cy="2219976"/>
                <a:chOff x="4487863" y="704728"/>
                <a:chExt cx="3305652" cy="2219976"/>
              </a:xfrm>
            </p:grpSpPr>
            <p:pic>
              <p:nvPicPr>
                <p:cNvPr id="47" name="Picture 7" descr="D:\Vivek\Gel pictrures\00 walking\vivek\Final Photograph\A4 &amp; A5 transgenic lines with hpt\UVP_00006Oct062010.JPG"/>
                <p:cNvPicPr>
                  <a:picLocks noChangeArrowheads="1"/>
                </p:cNvPicPr>
                <p:nvPr/>
              </p:nvPicPr>
              <p:blipFill rotWithShape="1">
                <a:blip r:embed="rId3" cstate="print"/>
                <a:srcRect l="11667" t="5086" r="46666" b="57777"/>
                <a:stretch/>
              </p:blipFill>
              <p:spPr bwMode="auto">
                <a:xfrm>
                  <a:off x="4487863" y="764704"/>
                  <a:ext cx="3240000" cy="21600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68" name="TextBox 18"/>
                <p:cNvSpPr txBox="1">
                  <a:spLocks noChangeArrowheads="1"/>
                </p:cNvSpPr>
                <p:nvPr/>
              </p:nvSpPr>
              <p:spPr bwMode="auto">
                <a:xfrm>
                  <a:off x="4569556" y="704728"/>
                  <a:ext cx="3223959" cy="3077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400" dirty="0" smtClean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  +</a:t>
                  </a:r>
                  <a:r>
                    <a:rPr lang="en-US" sz="1400" dirty="0" err="1" smtClean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ve</a:t>
                  </a:r>
                  <a:r>
                    <a:rPr lang="en-US" sz="1400" dirty="0" smtClean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-</a:t>
                  </a:r>
                  <a:r>
                    <a:rPr lang="en-US" sz="1400" dirty="0" err="1" smtClean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ve</a:t>
                  </a:r>
                  <a:r>
                    <a:rPr lang="en-US" sz="1400" dirty="0" smtClean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L1  L2   L3  L4   L5   L6   L7</a:t>
                  </a:r>
                  <a:endParaRPr lang="en-US" sz="14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71" name="Group 70"/>
              <p:cNvGrpSpPr/>
              <p:nvPr/>
            </p:nvGrpSpPr>
            <p:grpSpPr>
              <a:xfrm>
                <a:off x="1235242" y="3056566"/>
                <a:ext cx="3246533" cy="2219976"/>
                <a:chOff x="838200" y="3225008"/>
                <a:chExt cx="3246533" cy="2219976"/>
              </a:xfrm>
            </p:grpSpPr>
            <p:pic>
              <p:nvPicPr>
                <p:cNvPr id="30" name="Picture 5" descr="D:\Vivek\Gel pictrures\00 walking\vivek\Final Photograph\A3 transgenic lines with hpt\UVP_00007Oct062010.JPG"/>
                <p:cNvPicPr>
                  <a:picLocks noChangeArrowheads="1"/>
                </p:cNvPicPr>
                <p:nvPr/>
              </p:nvPicPr>
              <p:blipFill rotWithShape="1">
                <a:blip r:embed="rId4" cstate="print"/>
                <a:srcRect l="13333" t="182" r="31667" b="60001"/>
                <a:stretch/>
              </p:blipFill>
              <p:spPr bwMode="auto">
                <a:xfrm>
                  <a:off x="838200" y="3284984"/>
                  <a:ext cx="3240000" cy="21600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69" name="TextBox 18"/>
                <p:cNvSpPr txBox="1">
                  <a:spLocks noChangeArrowheads="1"/>
                </p:cNvSpPr>
                <p:nvPr/>
              </p:nvSpPr>
              <p:spPr bwMode="auto">
                <a:xfrm>
                  <a:off x="860774" y="3225008"/>
                  <a:ext cx="3223959" cy="3077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400" dirty="0" smtClean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  +</a:t>
                  </a:r>
                  <a:r>
                    <a:rPr lang="en-US" sz="1400" dirty="0" err="1" smtClean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ve</a:t>
                  </a:r>
                  <a:r>
                    <a:rPr lang="en-US" sz="1400" dirty="0" smtClean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-</a:t>
                  </a:r>
                  <a:r>
                    <a:rPr lang="en-US" sz="1400" dirty="0" err="1" smtClean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ve</a:t>
                  </a:r>
                  <a:r>
                    <a:rPr lang="en-US" sz="1400" dirty="0" smtClean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L1  L2   L3  L4   L5   L6   L7</a:t>
                  </a:r>
                  <a:endParaRPr lang="en-US" sz="14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73" name="Group 72"/>
              <p:cNvGrpSpPr/>
              <p:nvPr/>
            </p:nvGrpSpPr>
            <p:grpSpPr>
              <a:xfrm>
                <a:off x="4522771" y="3042716"/>
                <a:ext cx="3278298" cy="2232193"/>
                <a:chOff x="4487863" y="3284800"/>
                <a:chExt cx="3278298" cy="2232193"/>
              </a:xfrm>
            </p:grpSpPr>
            <p:pic>
              <p:nvPicPr>
                <p:cNvPr id="64" name="Picture 8" descr="D:\Vivek\Gel pictrures\00 walking\vivek\Final Photograph\A4 &amp; A5 transgenic lines with hpt\UVP_00006Oct062010.JPG"/>
                <p:cNvPicPr>
                  <a:picLocks noChangeArrowheads="1"/>
                </p:cNvPicPr>
                <p:nvPr/>
              </p:nvPicPr>
              <p:blipFill rotWithShape="1">
                <a:blip r:embed="rId3" cstate="print"/>
                <a:srcRect l="52499" t="4961" r="7019" b="56667"/>
                <a:stretch/>
              </p:blipFill>
              <p:spPr bwMode="auto">
                <a:xfrm>
                  <a:off x="4487863" y="3356993"/>
                  <a:ext cx="3240000" cy="21600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72" name="TextBox 18"/>
                <p:cNvSpPr txBox="1">
                  <a:spLocks noChangeArrowheads="1"/>
                </p:cNvSpPr>
                <p:nvPr/>
              </p:nvSpPr>
              <p:spPr bwMode="auto">
                <a:xfrm>
                  <a:off x="4497317" y="3284800"/>
                  <a:ext cx="3268844" cy="3077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400" dirty="0" smtClean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  +</a:t>
                  </a:r>
                  <a:r>
                    <a:rPr lang="en-US" sz="1400" dirty="0" err="1" smtClean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ve</a:t>
                  </a:r>
                  <a:r>
                    <a:rPr lang="en-US" sz="1400" dirty="0" smtClean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-</a:t>
                  </a:r>
                  <a:r>
                    <a:rPr lang="en-US" sz="1400" dirty="0" err="1" smtClean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ve</a:t>
                  </a:r>
                  <a:r>
                    <a:rPr lang="en-US" sz="1400" dirty="0" smtClean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 L1  L2   L3  L4   L5   L6   L7</a:t>
                  </a:r>
                  <a:endParaRPr lang="en-US" sz="14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7" name="TextBox 6"/>
            <p:cNvSpPr txBox="1"/>
            <p:nvPr/>
          </p:nvSpPr>
          <p:spPr>
            <a:xfrm>
              <a:off x="4242472" y="2666913"/>
              <a:ext cx="3634328" cy="27084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                                                        b</a:t>
              </a:r>
            </a:p>
            <a:p>
              <a:endParaRPr lang="en-GB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GB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GB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GB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GB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GB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GB" sz="2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GB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                                                        d</a:t>
              </a:r>
              <a:endParaRPr lang="en-US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8565992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80</TotalTime>
  <Words>101</Words>
  <Application>Microsoft Office PowerPoint</Application>
  <PresentationFormat>On-screen Show (4:3)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Mangal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VEKANAND</dc:creator>
  <cp:lastModifiedBy>Avinash Mishra</cp:lastModifiedBy>
  <cp:revision>60</cp:revision>
  <dcterms:created xsi:type="dcterms:W3CDTF">2015-06-06T07:44:47Z</dcterms:created>
  <dcterms:modified xsi:type="dcterms:W3CDTF">2015-12-28T07:04:50Z</dcterms:modified>
</cp:coreProperties>
</file>